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D2476-4679-4080-BAFE-6A1FA6EDFF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28BF2-6E25-432E-82EF-1C87A231FC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ECA62-B56C-437A-BB80-A73CF96577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C2703-91CC-4B94-AA67-39805893F6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47FF43-14AD-4580-B9CB-14FCC1F8EC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58B98-FF3D-4DF2-982B-9E813FA6D8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67A5A-A416-4246-9EE3-FFFA2899C9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D71B1-4465-456D-9665-FC14C1971A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453BB-1CE9-495C-B94D-DCAE14D11B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13D28-940D-4FAF-9646-3FF356C0D2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905D2-54AD-47E7-B59A-97BCE0121A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4445D-40A3-4D00-9693-EB85FA2ADC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3DCBEC-E192-4911-B2BB-C637ADA62EC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19320" y="113364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967680" y="115416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‘ AAU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922400" y="127620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498760" y="127620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V="1">
            <a:off x="2460600" y="8870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982880" y="622440"/>
            <a:ext cx="94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leavage si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963520" y="1155600"/>
            <a:ext cx="107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GUU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G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986280" y="127800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437000" y="1157400"/>
            <a:ext cx="20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UUGG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UG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UUUG 3‘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982520" y="101268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580840" y="101448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003200" y="10144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19320" y="154620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967680" y="156672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‘ AAU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"/>
          <p:cNvGrpSpPr/>
          <p:nvPr/>
        </p:nvGrpSpPr>
        <p:grpSpPr>
          <a:xfrm>
            <a:off x="1922400" y="1425600"/>
            <a:ext cx="2390040" cy="419400"/>
            <a:chOff x="1922400" y="1425600"/>
            <a:chExt cx="2390040" cy="419400"/>
          </a:xfrm>
        </p:grpSpPr>
        <p:sp>
          <p:nvSpPr>
            <p:cNvPr id="56" name=""/>
            <p:cNvSpPr/>
            <p:nvPr/>
          </p:nvSpPr>
          <p:spPr>
            <a:xfrm>
              <a:off x="1922400" y="168912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98760" y="168912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962800" y="1568520"/>
              <a:ext cx="134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G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UUUUU 3‘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982160" y="142560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580840" y="142704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"/>
          <p:cNvSpPr/>
          <p:nvPr/>
        </p:nvSpPr>
        <p:spPr>
          <a:xfrm>
            <a:off x="319320" y="196524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972360" y="197964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‘ AAU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1927080" y="1838160"/>
            <a:ext cx="6239520" cy="421200"/>
            <a:chOff x="1927080" y="1838160"/>
            <a:chExt cx="6239520" cy="421200"/>
          </a:xfrm>
        </p:grpSpPr>
        <p:sp>
          <p:nvSpPr>
            <p:cNvPr id="64" name=""/>
            <p:cNvSpPr/>
            <p:nvPr/>
          </p:nvSpPr>
          <p:spPr>
            <a:xfrm>
              <a:off x="1927080" y="210168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503080" y="2101680"/>
              <a:ext cx="50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967840" y="1981080"/>
              <a:ext cx="144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GUUG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C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UUU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986840" y="183816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585160" y="183996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2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360680" y="210348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811040" y="1982880"/>
              <a:ext cx="3355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UUUGUGUUUUUG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UU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G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GUUG 3‘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377600" y="183996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"/>
          <p:cNvSpPr/>
          <p:nvPr/>
        </p:nvSpPr>
        <p:spPr>
          <a:xfrm>
            <a:off x="319320" y="238752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967680" y="239724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‘ AAU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"/>
          <p:cNvGrpSpPr/>
          <p:nvPr/>
        </p:nvGrpSpPr>
        <p:grpSpPr>
          <a:xfrm>
            <a:off x="1922400" y="2255760"/>
            <a:ext cx="2956680" cy="419400"/>
            <a:chOff x="1922400" y="2255760"/>
            <a:chExt cx="2956680" cy="419400"/>
          </a:xfrm>
        </p:grpSpPr>
        <p:sp>
          <p:nvSpPr>
            <p:cNvPr id="75" name=""/>
            <p:cNvSpPr/>
            <p:nvPr/>
          </p:nvSpPr>
          <p:spPr>
            <a:xfrm>
              <a:off x="1922400" y="251928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498400" y="2519280"/>
              <a:ext cx="50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962080" y="2398680"/>
              <a:ext cx="191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GUUUG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UG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UU 3‘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981800" y="225576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580480" y="225756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"/>
          <p:cNvSpPr/>
          <p:nvPr/>
        </p:nvSpPr>
        <p:spPr>
          <a:xfrm>
            <a:off x="975600" y="503244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‘ AAU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925640" y="518004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502000" y="518004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965680" y="5057640"/>
            <a:ext cx="151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GUUG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C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UU 3‘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985400" y="49165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584080" y="49179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52360" y="501804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PA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52360" y="46386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PA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988200" y="464832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‘ AAU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938240" y="4795920"/>
            <a:ext cx="505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514600" y="479592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977200" y="4673520"/>
            <a:ext cx="326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UUUU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GU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UUUGGGU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UGG 3‘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998000" y="4532400"/>
            <a:ext cx="49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b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597040" y="453384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26440" y="403200"/>
            <a:ext cx="76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26080" y="3532320"/>
            <a:ext cx="40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52360" y="425304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PA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975600" y="426240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‘ AAU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8" name=""/>
          <p:cNvGrpSpPr/>
          <p:nvPr/>
        </p:nvGrpSpPr>
        <p:grpSpPr>
          <a:xfrm>
            <a:off x="1925640" y="4146480"/>
            <a:ext cx="2204280" cy="417960"/>
            <a:chOff x="1925640" y="4146480"/>
            <a:chExt cx="2204280" cy="417960"/>
          </a:xfrm>
        </p:grpSpPr>
        <p:sp>
          <p:nvSpPr>
            <p:cNvPr id="99" name=""/>
            <p:cNvSpPr/>
            <p:nvPr/>
          </p:nvSpPr>
          <p:spPr>
            <a:xfrm>
              <a:off x="1925640" y="441000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501640" y="4410000"/>
              <a:ext cx="50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966040" y="4287960"/>
              <a:ext cx="116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UUU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U 3‘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985400" y="414648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7bp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583720" y="4148280"/>
              <a:ext cx="46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4" name=""/>
          <p:cNvSpPr/>
          <p:nvPr/>
        </p:nvSpPr>
        <p:spPr>
          <a:xfrm>
            <a:off x="1994040" y="3759120"/>
            <a:ext cx="94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leavage si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flipV="1">
            <a:off x="2457360" y="399528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31T12:43:50Z</dcterms:created>
  <dc:creator>Administrator</dc:creator>
  <dc:description/>
  <dc:language>en-US</dc:language>
  <cp:lastModifiedBy>Administrator</cp:lastModifiedBy>
  <dcterms:modified xsi:type="dcterms:W3CDTF">2007-09-04T11:37:37Z</dcterms:modified>
  <cp:revision>11</cp:revision>
  <dc:subject/>
  <dc:title>Slide 1</dc:title>
</cp:coreProperties>
</file>